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7" d="100"/>
          <a:sy n="87" d="100"/>
        </p:scale>
        <p:origin x="61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822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799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412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771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55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757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58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039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917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600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215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D5515B-1453-43C5-AB1F-430239876D7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62EF0-C2E2-413D-840A-1E6D2CC917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06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35035" t="8302" r="9824" b="15475"/>
          <a:stretch/>
        </p:blipFill>
        <p:spPr>
          <a:xfrm>
            <a:off x="2907887" y="203467"/>
            <a:ext cx="6376226" cy="56578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37711" y="6377389"/>
            <a:ext cx="114014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S1: </a:t>
            </a:r>
            <a:r>
              <a:rPr lang="en-US" smtClean="0"/>
              <a:t>Geographic origin of </a:t>
            </a:r>
            <a:r>
              <a:rPr lang="en-US" dirty="0" smtClean="0"/>
              <a:t>the 88 analyzed genotypes of </a:t>
            </a:r>
            <a:r>
              <a:rPr lang="en-US" i="1" dirty="0" err="1" smtClean="0"/>
              <a:t>Eremurus</a:t>
            </a:r>
            <a:r>
              <a:rPr lang="en-US" dirty="0" smtClean="0"/>
              <a:t> spp. sampled across Ira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67135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Franklin College - University of Georg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rien M. Devos</dc:creator>
  <cp:lastModifiedBy>Katrien M. Devos</cp:lastModifiedBy>
  <cp:revision>2</cp:revision>
  <dcterms:created xsi:type="dcterms:W3CDTF">2019-07-25T11:43:33Z</dcterms:created>
  <dcterms:modified xsi:type="dcterms:W3CDTF">2020-02-08T21:08:50Z</dcterms:modified>
</cp:coreProperties>
</file>